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8" r:id="rId2"/>
    <p:sldId id="319" r:id="rId3"/>
    <p:sldId id="280" r:id="rId4"/>
    <p:sldId id="257" r:id="rId5"/>
    <p:sldId id="264" r:id="rId6"/>
    <p:sldId id="260" r:id="rId7"/>
    <p:sldId id="277" r:id="rId8"/>
    <p:sldId id="266" r:id="rId9"/>
    <p:sldId id="279" r:id="rId10"/>
    <p:sldId id="258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7988"/>
    <p:restoredTop sz="94629"/>
  </p:normalViewPr>
  <p:slideViewPr>
    <p:cSldViewPr snapToGrid="0" snapToObjects="1">
      <p:cViewPr varScale="1">
        <p:scale>
          <a:sx n="118" d="100"/>
          <a:sy n="118" d="100"/>
        </p:scale>
        <p:origin x="216" y="1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0CC9B-7B1E-CF4C-A1FC-5F0280AA1B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BD323A-BC9A-C247-A85B-AE7209660B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4263B-D862-0945-B607-3B0A6D8E0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C33409-A37A-084C-A43F-ABF9511A5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FFDE88-DF47-344D-8231-9BC913A1F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630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30CD77-F504-F342-B644-183F24167F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7F1829-14D9-0B47-AB90-5072EE1EEF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94CF12-3553-2E47-A20D-198EA7042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33959C-54C1-4345-9E31-9B077727A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79B4D-7AD0-9945-B7E7-56751B8FD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601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4B07CE7-78C6-244D-9ED0-491941318E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9729ED-238E-AF45-ABC0-B740B2C171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704D94-4165-6846-9A82-91539F8CD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F381D2-EEC0-414B-A115-AF0DF95B7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556490-8E6B-144A-BBC1-B7C94F1CB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127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EE291-F8EE-3942-874C-F0658844C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6F457D-75E4-7749-9C5C-F45CF8CE7F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8B97AE-749D-9645-8094-6C9C90896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1BF087-78B9-B242-A803-1A3D5E147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0944F8-9E98-7947-848E-1279A31A9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14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A5BEE-419F-5149-B366-775BC7A248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00BBE8-DCF8-C14A-A570-B3B1A3BB0C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794666-DFF6-2F42-90C1-C59ED106C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49A5C-2F2E-8645-992F-021AD9ACF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A2670F-DAE0-F74B-A6F4-42DB0A845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38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9C694-99B2-E647-9579-8AE599950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2A3771-971D-0440-BB29-A50821438F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6A70B2-77E4-6E40-9E6F-B3507E2305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FD6588-89CD-EB46-9569-9EC8A5B2F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6EA13F-B45E-CE4E-8FC6-646F8ABCA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4BCE09-0424-444E-8D07-6ECF1377A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419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A7777-D6C2-A243-86FC-44F5BD25F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61ED36-8841-9B41-A364-CD146F2183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0244C9-136E-6E4A-873C-17DED49496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0127BA-17EB-FE4B-9666-9B3E42CF23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D0FB0C-C046-3648-8C7B-8F9FD85F25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291C65-54C2-B14B-B61D-FBEF86F2E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93C9F6-578F-B644-AB75-A03F97732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474A2A7-1136-2D40-AB51-0FD248EAF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291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50FA5-814D-5448-A439-DF8626953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7084CC-A32E-B448-91D8-EE2FA6789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819BCD-8FE5-934C-A752-99DD30BF4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DC038A-2407-ED47-BD6B-D39E6D2A6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508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C87A81-50C0-C948-BBA8-E5C679500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1D1FB1-D794-7045-B169-E1FFBF05E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F2C295-E2C1-EA42-8417-FDAAE76AB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080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CDC0E9-C28E-2146-BF24-BBDD0B7522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ED9093-E362-7E41-9C9E-482FD756EB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F269D0-F6C3-6641-8772-B09D4203F1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1EFE82-A190-7A40-8EB8-5B0939E84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4DFF52-9C0E-2948-877B-EFF73D0A5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E82FBB-D105-9248-AE5A-9439BC925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19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12BCBE-144A-1B44-B4CE-72717B2C9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1C5C9A-23B5-D94D-BFFD-85A445960F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FC3456-1C68-654D-89E4-AD61AF310E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421431-B574-8542-8517-0EF898D1A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CDA23B-0175-A34F-AAE6-5E0C6A8DF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4772A1-B7E7-C942-A62F-85BA60041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337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2D84A4-4A91-E340-BB3F-D5E5CECE03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E10A34-89B0-DF47-8C2A-B70B9D1563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95EB6B-DD35-DB40-B1D4-60052BAD2D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ADA950-A5F3-A04B-BE12-57F26A316F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CF8D8D-FD0E-E140-8BBB-CC86194C90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855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0D72891-E6EF-9749-94CF-7D831034B12E}"/>
              </a:ext>
            </a:extLst>
          </p:cNvPr>
          <p:cNvGrpSpPr/>
          <p:nvPr/>
        </p:nvGrpSpPr>
        <p:grpSpPr>
          <a:xfrm>
            <a:off x="3251172" y="461561"/>
            <a:ext cx="6319241" cy="1176592"/>
            <a:chOff x="165327" y="99611"/>
            <a:chExt cx="6319241" cy="1176592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4ED802D-3226-A047-8BBB-33025028CABA}"/>
                </a:ext>
              </a:extLst>
            </p:cNvPr>
            <p:cNvSpPr txBox="1"/>
            <p:nvPr/>
          </p:nvSpPr>
          <p:spPr>
            <a:xfrm>
              <a:off x="165327" y="99611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59a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26053EB-56BD-804D-8C7D-9110A08C1F02}"/>
                </a:ext>
              </a:extLst>
            </p:cNvPr>
            <p:cNvSpPr txBox="1"/>
            <p:nvPr/>
          </p:nvSpPr>
          <p:spPr>
            <a:xfrm>
              <a:off x="1275753" y="468943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044A7EE-76A5-7245-9AAB-247DF814C2A0}"/>
                </a:ext>
              </a:extLst>
            </p:cNvPr>
            <p:cNvSpPr txBox="1"/>
            <p:nvPr/>
          </p:nvSpPr>
          <p:spPr>
            <a:xfrm>
              <a:off x="595396" y="90687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CS      TS.     CR.    TR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01888F37-8055-9C4F-B14F-FF92D106DE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3840" y="1638300"/>
            <a:ext cx="5664200" cy="358140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09684A8-9018-134B-86DE-A9E6976EF8D5}"/>
              </a:ext>
            </a:extLst>
          </p:cNvPr>
          <p:cNvSpPr/>
          <p:nvPr/>
        </p:nvSpPr>
        <p:spPr>
          <a:xfrm>
            <a:off x="201569" y="1303552"/>
            <a:ext cx="2595582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100" b="1" dirty="0">
                <a:latin typeface="Calibri" panose="020F0502020204030204" pitchFamily="34" charset="0"/>
              </a:rPr>
              <a:t>S4 File: Uncropped Northern blot images </a:t>
            </a:r>
          </a:p>
          <a:p>
            <a:r>
              <a:rPr lang="en-IN" sz="1100" b="1" dirty="0">
                <a:latin typeface="Calibri" panose="020F0502020204030204" pitchFamily="34" charset="0"/>
              </a:rPr>
              <a:t>of known and novel miRNAs</a:t>
            </a:r>
            <a:endParaRPr lang="en-IN" sz="1100" dirty="0">
              <a:latin typeface="Calibri" panose="020F050202020403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55DE4B2-4D37-BD44-A0DC-5B4CA78FA359}"/>
              </a:ext>
            </a:extLst>
          </p:cNvPr>
          <p:cNvSpPr/>
          <p:nvPr/>
        </p:nvSpPr>
        <p:spPr>
          <a:xfrm>
            <a:off x="201569" y="328515"/>
            <a:ext cx="292263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100" b="1" dirty="0">
                <a:latin typeface="Arial" panose="020B0604020202020204" pitchFamily="34" charset="0"/>
              </a:rPr>
              <a:t>Identification and expression analysis of miRNAs and elucidation of their role in salt tolerance in rice varieties susceptible and tolerant to salinity</a:t>
            </a:r>
            <a:endParaRPr lang="en-IN" sz="11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29729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9A794081-C41F-B249-A434-D0A7AF17D818}"/>
              </a:ext>
            </a:extLst>
          </p:cNvPr>
          <p:cNvGrpSpPr/>
          <p:nvPr/>
        </p:nvGrpSpPr>
        <p:grpSpPr>
          <a:xfrm>
            <a:off x="1714500" y="278007"/>
            <a:ext cx="7184572" cy="881857"/>
            <a:chOff x="1714500" y="278007"/>
            <a:chExt cx="7184572" cy="88185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77FA38E-A5F0-5F45-B294-4EA3D62FB5FF}"/>
                </a:ext>
              </a:extLst>
            </p:cNvPr>
            <p:cNvSpPr txBox="1"/>
            <p:nvPr/>
          </p:nvSpPr>
          <p:spPr>
            <a:xfrm>
              <a:off x="3690257" y="352604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7E63034-665C-634A-9058-B15B7DB38C0F}"/>
                </a:ext>
              </a:extLst>
            </p:cNvPr>
            <p:cNvSpPr txBox="1"/>
            <p:nvPr/>
          </p:nvSpPr>
          <p:spPr>
            <a:xfrm>
              <a:off x="3009900" y="790532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   CS      TS.        CR.       TR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3800ACE-3597-3D44-89E7-C54F7C7590D4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81</a:t>
              </a:r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7564CBAD-E047-5544-BF1F-6DEB10A6FF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9307" y="1228460"/>
            <a:ext cx="6350000" cy="459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00558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675A672-7F2C-4245-915A-48C79570231F}"/>
              </a:ext>
            </a:extLst>
          </p:cNvPr>
          <p:cNvGrpSpPr/>
          <p:nvPr/>
        </p:nvGrpSpPr>
        <p:grpSpPr>
          <a:xfrm>
            <a:off x="1714500" y="278007"/>
            <a:ext cx="7184572" cy="881857"/>
            <a:chOff x="1714500" y="278007"/>
            <a:chExt cx="7184572" cy="88185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C7FAD71-6AA5-3E4C-87A8-2D8CA159FBDF}"/>
                </a:ext>
              </a:extLst>
            </p:cNvPr>
            <p:cNvSpPr txBox="1"/>
            <p:nvPr/>
          </p:nvSpPr>
          <p:spPr>
            <a:xfrm>
              <a:off x="3690257" y="352604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4C385EE-0206-7047-B3F9-A6966422BD18}"/>
                </a:ext>
              </a:extLst>
            </p:cNvPr>
            <p:cNvSpPr txBox="1"/>
            <p:nvPr/>
          </p:nvSpPr>
          <p:spPr>
            <a:xfrm>
              <a:off x="3009900" y="790532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   CS      TS.        CR.       TR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04B658E-B714-1346-8EA2-B66D272B8355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82</a:t>
              </a:r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E8D216F9-7578-9648-B4C0-3E975852396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9183"/>
          <a:stretch/>
        </p:blipFill>
        <p:spPr>
          <a:xfrm>
            <a:off x="2339340" y="1303056"/>
            <a:ext cx="6099802" cy="4764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5235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445085D-E29C-E648-9AFB-A71EE0F85473}"/>
              </a:ext>
            </a:extLst>
          </p:cNvPr>
          <p:cNvGrpSpPr/>
          <p:nvPr/>
        </p:nvGrpSpPr>
        <p:grpSpPr>
          <a:xfrm>
            <a:off x="3251172" y="461561"/>
            <a:ext cx="6319241" cy="1176592"/>
            <a:chOff x="165327" y="99611"/>
            <a:chExt cx="6319241" cy="1176592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EE70FC6-16B9-7F41-BB35-905B6482A0C6}"/>
                </a:ext>
              </a:extLst>
            </p:cNvPr>
            <p:cNvSpPr txBox="1"/>
            <p:nvPr/>
          </p:nvSpPr>
          <p:spPr>
            <a:xfrm>
              <a:off x="165327" y="99611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67f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975FD7D-9E37-A94E-B82F-9CA252D8E5CD}"/>
                </a:ext>
              </a:extLst>
            </p:cNvPr>
            <p:cNvSpPr txBox="1"/>
            <p:nvPr/>
          </p:nvSpPr>
          <p:spPr>
            <a:xfrm>
              <a:off x="1275753" y="468943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01B0001-3E5F-1444-B78F-FA73329C8F3F}"/>
                </a:ext>
              </a:extLst>
            </p:cNvPr>
            <p:cNvSpPr txBox="1"/>
            <p:nvPr/>
          </p:nvSpPr>
          <p:spPr>
            <a:xfrm>
              <a:off x="595396" y="90687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CS      TS.     CR.    TR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1A1F18D3-56DF-A443-B76B-BDA01A0C29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9900" y="1774190"/>
            <a:ext cx="5880156" cy="4178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5882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A98F1DF3-F9E0-CD4C-A99F-A0B0B5FCA293}"/>
              </a:ext>
            </a:extLst>
          </p:cNvPr>
          <p:cNvGrpSpPr/>
          <p:nvPr/>
        </p:nvGrpSpPr>
        <p:grpSpPr>
          <a:xfrm>
            <a:off x="3251172" y="556811"/>
            <a:ext cx="6128741" cy="1650624"/>
            <a:chOff x="165327" y="99611"/>
            <a:chExt cx="6128741" cy="1650624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1F4355D-CC68-504F-8550-4709ACD1470E}"/>
                </a:ext>
              </a:extLst>
            </p:cNvPr>
            <p:cNvSpPr txBox="1"/>
            <p:nvPr/>
          </p:nvSpPr>
          <p:spPr>
            <a:xfrm>
              <a:off x="165327" y="99611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74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9B50949-5815-3948-ADBE-D164CC89267C}"/>
                </a:ext>
              </a:extLst>
            </p:cNvPr>
            <p:cNvSpPr txBox="1"/>
            <p:nvPr/>
          </p:nvSpPr>
          <p:spPr>
            <a:xfrm>
              <a:off x="1085253" y="942975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8F78849-CEA0-E740-912F-A6672DA192D8}"/>
                </a:ext>
              </a:extLst>
            </p:cNvPr>
            <p:cNvSpPr txBox="1"/>
            <p:nvPr/>
          </p:nvSpPr>
          <p:spPr>
            <a:xfrm>
              <a:off x="404896" y="1380903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CS      TS.     CR.    TR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855F35C3-1C94-BF48-ACCC-866E06DD44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018"/>
          <a:stretch/>
        </p:blipFill>
        <p:spPr>
          <a:xfrm>
            <a:off x="3251200" y="2217420"/>
            <a:ext cx="4908962" cy="3451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5524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04519A1-FA77-EA4E-AFEB-AD3DA34F5EF8}"/>
              </a:ext>
            </a:extLst>
          </p:cNvPr>
          <p:cNvSpPr txBox="1"/>
          <p:nvPr/>
        </p:nvSpPr>
        <p:spPr>
          <a:xfrm>
            <a:off x="3249385" y="489858"/>
            <a:ext cx="1763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iR1247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C484F0A-51EE-B247-A005-AEBE7CBB03FE}"/>
              </a:ext>
            </a:extLst>
          </p:cNvPr>
          <p:cNvSpPr txBox="1"/>
          <p:nvPr/>
        </p:nvSpPr>
        <p:spPr>
          <a:xfrm>
            <a:off x="4245429" y="859190"/>
            <a:ext cx="5208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okkali</a:t>
            </a:r>
            <a:r>
              <a:rPr lang="en-US" dirty="0"/>
              <a:t>                           Badam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BA9318-63AF-5E4C-83E8-F697EFEC0F4D}"/>
              </a:ext>
            </a:extLst>
          </p:cNvPr>
          <p:cNvSpPr txBox="1"/>
          <p:nvPr/>
        </p:nvSpPr>
        <p:spPr>
          <a:xfrm>
            <a:off x="3565072" y="1297118"/>
            <a:ext cx="5208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S      TS.     CR.     TR      CS      TS.     CR.    TR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CBCFD6C-063E-5546-917B-3877A07A7A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5072" y="1712782"/>
            <a:ext cx="4546600" cy="384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8650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468DD6E-09C7-1046-914E-5B0B7FA936F7}"/>
              </a:ext>
            </a:extLst>
          </p:cNvPr>
          <p:cNvGrpSpPr/>
          <p:nvPr/>
        </p:nvGrpSpPr>
        <p:grpSpPr>
          <a:xfrm>
            <a:off x="3755571" y="245351"/>
            <a:ext cx="6096000" cy="1355386"/>
            <a:chOff x="1714500" y="278007"/>
            <a:chExt cx="6096000" cy="1355386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D80A1B5-D745-6947-918A-134539CD5719}"/>
                </a:ext>
              </a:extLst>
            </p:cNvPr>
            <p:cNvSpPr txBox="1"/>
            <p:nvPr/>
          </p:nvSpPr>
          <p:spPr>
            <a:xfrm>
              <a:off x="2601685" y="826133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5637118-F4F5-ED4E-8B96-E7E381B68926}"/>
                </a:ext>
              </a:extLst>
            </p:cNvPr>
            <p:cNvSpPr txBox="1"/>
            <p:nvPr/>
          </p:nvSpPr>
          <p:spPr>
            <a:xfrm>
              <a:off x="1921328" y="126406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    CR.     TR         CS      TS.        CR.    TR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1F0475E-0F2B-CD4C-BE6F-E4C192156174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76</a:t>
              </a:r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D2AA55B0-BD41-1E48-A24E-49AE9E8C95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6800" y="1744980"/>
            <a:ext cx="5207000" cy="441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17932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730B189-107C-EE4D-AF47-1F08EE34D8E5}"/>
              </a:ext>
            </a:extLst>
          </p:cNvPr>
          <p:cNvSpPr txBox="1"/>
          <p:nvPr/>
        </p:nvSpPr>
        <p:spPr>
          <a:xfrm>
            <a:off x="3317421" y="272944"/>
            <a:ext cx="1763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iR12477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BC9A208-6FBF-BE47-AEFA-7E63A5AD50E5}"/>
              </a:ext>
            </a:extLst>
          </p:cNvPr>
          <p:cNvGrpSpPr/>
          <p:nvPr/>
        </p:nvGrpSpPr>
        <p:grpSpPr>
          <a:xfrm>
            <a:off x="3491592" y="821073"/>
            <a:ext cx="5889172" cy="807260"/>
            <a:chOff x="1921328" y="826133"/>
            <a:chExt cx="5889172" cy="807260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BF65639-C05A-4845-B18C-F9FB5685F235}"/>
                </a:ext>
              </a:extLst>
            </p:cNvPr>
            <p:cNvSpPr txBox="1"/>
            <p:nvPr/>
          </p:nvSpPr>
          <p:spPr>
            <a:xfrm>
              <a:off x="2601685" y="826133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9350240-87B6-FA43-BFD1-641DA9ECCF3E}"/>
                </a:ext>
              </a:extLst>
            </p:cNvPr>
            <p:cNvSpPr txBox="1"/>
            <p:nvPr/>
          </p:nvSpPr>
          <p:spPr>
            <a:xfrm>
              <a:off x="1921328" y="126406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    CR.     TR         CS      TS.        CR.    TR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B2C490A5-6EA0-9449-9560-8A2F405E5F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3380" y="1565910"/>
            <a:ext cx="6273800" cy="4914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44460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99DA8B7C-D2A5-1B4C-A9A7-70E7407A30A8}"/>
              </a:ext>
            </a:extLst>
          </p:cNvPr>
          <p:cNvGrpSpPr/>
          <p:nvPr/>
        </p:nvGrpSpPr>
        <p:grpSpPr>
          <a:xfrm>
            <a:off x="3639570" y="81643"/>
            <a:ext cx="6128741" cy="1650624"/>
            <a:chOff x="165327" y="99611"/>
            <a:chExt cx="6128741" cy="1650624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5CE045F-6CCE-2746-87F1-83949A7C2729}"/>
                </a:ext>
              </a:extLst>
            </p:cNvPr>
            <p:cNvSpPr txBox="1"/>
            <p:nvPr/>
          </p:nvSpPr>
          <p:spPr>
            <a:xfrm>
              <a:off x="165327" y="99611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78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751B26C-2078-A644-8978-F84B6791E562}"/>
                </a:ext>
              </a:extLst>
            </p:cNvPr>
            <p:cNvSpPr txBox="1"/>
            <p:nvPr/>
          </p:nvSpPr>
          <p:spPr>
            <a:xfrm>
              <a:off x="1085253" y="942975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5A153C6-A9EC-8345-8215-FDEFD5E37C55}"/>
                </a:ext>
              </a:extLst>
            </p:cNvPr>
            <p:cNvSpPr txBox="1"/>
            <p:nvPr/>
          </p:nvSpPr>
          <p:spPr>
            <a:xfrm>
              <a:off x="404896" y="1380903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CS      TS.     CR.    TR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E62DA34F-89F2-374C-9786-6A884B622F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4880" y="1768371"/>
            <a:ext cx="4902200" cy="434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68453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39E7FF53-C2C0-2242-8885-6A6B0990FBA6}"/>
              </a:ext>
            </a:extLst>
          </p:cNvPr>
          <p:cNvGrpSpPr/>
          <p:nvPr/>
        </p:nvGrpSpPr>
        <p:grpSpPr>
          <a:xfrm>
            <a:off x="3173185" y="65314"/>
            <a:ext cx="6302829" cy="1295095"/>
            <a:chOff x="2596243" y="-135231"/>
            <a:chExt cx="6302829" cy="1295095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86D1C60-EEB4-DF41-A95E-64DA89BE19B9}"/>
                </a:ext>
              </a:extLst>
            </p:cNvPr>
            <p:cNvSpPr txBox="1"/>
            <p:nvPr/>
          </p:nvSpPr>
          <p:spPr>
            <a:xfrm>
              <a:off x="3690257" y="352604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7E3AC8E-B210-F24E-87B6-D23255848A00}"/>
                </a:ext>
              </a:extLst>
            </p:cNvPr>
            <p:cNvSpPr txBox="1"/>
            <p:nvPr/>
          </p:nvSpPr>
          <p:spPr>
            <a:xfrm>
              <a:off x="3009900" y="790532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   CS      TS.        CR.       TR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E20A5EA-1ED3-B748-BE5A-6E76C40AA8D9}"/>
                </a:ext>
              </a:extLst>
            </p:cNvPr>
            <p:cNvSpPr txBox="1"/>
            <p:nvPr/>
          </p:nvSpPr>
          <p:spPr>
            <a:xfrm>
              <a:off x="2596243" y="-135231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79</a:t>
              </a: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A5572B4C-7913-E44F-8231-208C36EDC9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7560" y="1372870"/>
            <a:ext cx="5334000" cy="488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658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E8CE20E-7D32-234E-8EA2-2239A1D7188D}"/>
              </a:ext>
            </a:extLst>
          </p:cNvPr>
          <p:cNvGrpSpPr/>
          <p:nvPr/>
        </p:nvGrpSpPr>
        <p:grpSpPr>
          <a:xfrm>
            <a:off x="1714500" y="278007"/>
            <a:ext cx="7184572" cy="881857"/>
            <a:chOff x="1714500" y="278007"/>
            <a:chExt cx="7184572" cy="881857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1AFA4AD-81F9-2340-85D9-9948532F9754}"/>
                </a:ext>
              </a:extLst>
            </p:cNvPr>
            <p:cNvSpPr txBox="1"/>
            <p:nvPr/>
          </p:nvSpPr>
          <p:spPr>
            <a:xfrm>
              <a:off x="3690257" y="352604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Pokkali</a:t>
              </a:r>
              <a:r>
                <a:rPr lang="en-US" dirty="0"/>
                <a:t>                           Badami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EC353AD-0AE7-694A-9815-399C15F128E6}"/>
                </a:ext>
              </a:extLst>
            </p:cNvPr>
            <p:cNvSpPr txBox="1"/>
            <p:nvPr/>
          </p:nvSpPr>
          <p:spPr>
            <a:xfrm>
              <a:off x="3009900" y="790532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CR.     TR             CS      TS.        CR.       TR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FB284C5-482C-4D4F-892C-7334C370CF30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80</a:t>
              </a:r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EAD51D26-1735-F54F-9798-2CB690ACF1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4200" y="1197610"/>
            <a:ext cx="6478815" cy="48889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4643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99</Words>
  <Application>Microsoft Macintosh PowerPoint</Application>
  <PresentationFormat>Widescreen</PresentationFormat>
  <Paragraphs>36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mar, Shaifaly (NIH/NCI) [F]</dc:creator>
  <cp:lastModifiedBy>Birendra Shaw</cp:lastModifiedBy>
  <cp:revision>5</cp:revision>
  <dcterms:created xsi:type="dcterms:W3CDTF">2019-11-13T04:48:55Z</dcterms:created>
  <dcterms:modified xsi:type="dcterms:W3CDTF">2020-02-15T07:45:17Z</dcterms:modified>
</cp:coreProperties>
</file>